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5"/>
  </p:notesMasterIdLst>
  <p:sldIdLst>
    <p:sldId id="265" r:id="rId3"/>
    <p:sldId id="264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6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14663D-4155-42BB-9CD9-47C86A131434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85EFDF-DC8F-4653-AA75-9C4BD5BB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646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2284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29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19539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3053319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26817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8664544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9409024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5052549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0766660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3912775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9361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195693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210265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221494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3418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195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718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5751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30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228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020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8985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57979-0887-4944-8F32-831F71FFD8A0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1AF3-FFCF-4958-8F67-65B11AD34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3643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B2E6BDA-F32C-48D6-8B52-7C33CFE9A757}" type="datetimeFigureOut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l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4-04-16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6858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AF6016E-CABA-4BE5-9AD9-55526F3F470C}" type="slidenum">
              <a:rPr kumimoji="0" lang="ko-KR" altLang="en-US" sz="9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맑은 고딕"/>
                <a:ea typeface="맑은 고딕" panose="020B0503020000020004" pitchFamily="50" charset="-127"/>
                <a:cs typeface="+mn-cs"/>
              </a:rPr>
              <a:pPr marL="0" marR="0" lvl="0" indent="0" algn="r" defTabSz="6858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ko-KR" altLang="en-US" sz="9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맑은 고딕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7769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3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8DD13F6-A65C-481C-8BC0-DA38DA3B8826}"/>
              </a:ext>
            </a:extLst>
          </p:cNvPr>
          <p:cNvSpPr txBox="1"/>
          <p:nvPr/>
        </p:nvSpPr>
        <p:spPr>
          <a:xfrm>
            <a:off x="0" y="0"/>
            <a:ext cx="886842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tuberculosis H37Rv </a:t>
            </a:r>
            <a:endParaRPr lang="en-US" altLang="ko-KR" sz="11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time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     Initial OD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5       </a:t>
            </a:r>
          </a:p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un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onylpromazine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DQ</a:t>
            </a:r>
            <a:endParaRPr lang="en-US" altLang="ko-K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cubation treat resazurin 0.025% (40 ul/well) for overnight</a:t>
            </a:r>
          </a:p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 by fluorescence extension 560 nm, emission 590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</a:p>
        </p:txBody>
      </p:sp>
      <p:graphicFrame>
        <p:nvGraphicFramePr>
          <p:cNvPr id="8" name="표 8">
            <a:extLst>
              <a:ext uri="{FF2B5EF4-FFF2-40B4-BE49-F238E27FC236}">
                <a16:creationId xmlns:a16="http://schemas.microsoft.com/office/drawing/2014/main" xmlns="" id="{23C5ABDC-CA33-41C0-9C8F-A77CB3AE8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1723100"/>
              </p:ext>
            </p:extLst>
          </p:nvPr>
        </p:nvGraphicFramePr>
        <p:xfrm>
          <a:off x="4798335" y="5034458"/>
          <a:ext cx="2525009" cy="10973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17977">
                  <a:extLst>
                    <a:ext uri="{9D8B030D-6E8A-4147-A177-3AD203B41FA5}">
                      <a16:colId xmlns:a16="http://schemas.microsoft.com/office/drawing/2014/main" xmlns="" val="3112482941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2083353072"/>
                    </a:ext>
                  </a:extLst>
                </a:gridCol>
              </a:tblGrid>
              <a:tr h="30485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</a:t>
                      </a:r>
                      <a:r>
                        <a:rPr lang="en-US" altLang="ko-KR" sz="1000" b="1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µM)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tuberculosis H37Rv </a:t>
                      </a: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6723231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ionylpromazine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914022375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Q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9683579"/>
                  </a:ext>
                </a:extLst>
              </a:tr>
            </a:tbl>
          </a:graphicData>
        </a:graphic>
      </p:graphicFrame>
      <p:graphicFrame>
        <p:nvGraphicFramePr>
          <p:cNvPr id="9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5528078"/>
              </p:ext>
            </p:extLst>
          </p:nvPr>
        </p:nvGraphicFramePr>
        <p:xfrm>
          <a:off x="3509963" y="1754188"/>
          <a:ext cx="5322887" cy="2462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158" name="Prism 9" r:id="rId3" imgW="5579943" imgH="2648213" progId="Prism9.Document">
                  <p:embed/>
                </p:oleObj>
              </mc:Choice>
              <mc:Fallback>
                <p:oleObj name="Prism 9" r:id="rId3" imgW="5579943" imgH="2648213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9963" y="1754188"/>
                        <a:ext cx="5322887" cy="24622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16316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1E5BF80-66E1-3699-9F00-648E4F9AD38D}"/>
              </a:ext>
            </a:extLst>
          </p:cNvPr>
          <p:cNvSpPr txBox="1"/>
          <p:nvPr/>
        </p:nvSpPr>
        <p:spPr>
          <a:xfrm>
            <a:off x="0" y="0"/>
            <a:ext cx="354895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DM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ko-KR" alt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/well</a:t>
            </a:r>
          </a:p>
          <a:p>
            <a:r>
              <a:rPr lang="en-US" altLang="ko-KR" sz="14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 tuberculosis H37Rv </a:t>
            </a:r>
            <a:endParaRPr lang="en-US" altLang="ko-KR" sz="1400" i="1" dirty="0" smtClean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I 1</a:t>
            </a: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DQ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4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pionylpromazine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en-US" altLang="ko-KR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12">
            <a:extLst>
              <a:ext uri="{FF2B5EF4-FFF2-40B4-BE49-F238E27FC236}">
                <a16:creationId xmlns:a16="http://schemas.microsoft.com/office/drawing/2014/main" xmlns="" id="{BD832B7A-AC24-48D7-9370-5A2B904FF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7803806"/>
              </p:ext>
            </p:extLst>
          </p:nvPr>
        </p:nvGraphicFramePr>
        <p:xfrm>
          <a:off x="3608388" y="1600200"/>
          <a:ext cx="4748212" cy="259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9173" name="Prism 9" r:id="rId3" imgW="4723180" imgH="2648213" progId="Prism9.Document">
                  <p:embed/>
                </p:oleObj>
              </mc:Choice>
              <mc:Fallback>
                <p:oleObj name="Prism 9" r:id="rId3" imgW="4723180" imgH="2648213" progId="Prism9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08388" y="1600200"/>
                        <a:ext cx="4748212" cy="25955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표 8">
            <a:extLst>
              <a:ext uri="{FF2B5EF4-FFF2-40B4-BE49-F238E27FC236}">
                <a16:creationId xmlns:a16="http://schemas.microsoft.com/office/drawing/2014/main" xmlns="" id="{23C5ABDC-CA33-41C0-9C8F-A77CB3AE8D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8807822"/>
              </p:ext>
            </p:extLst>
          </p:nvPr>
        </p:nvGraphicFramePr>
        <p:xfrm>
          <a:off x="4798335" y="5034458"/>
          <a:ext cx="2525009" cy="10973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17977">
                  <a:extLst>
                    <a:ext uri="{9D8B030D-6E8A-4147-A177-3AD203B41FA5}">
                      <a16:colId xmlns:a16="http://schemas.microsoft.com/office/drawing/2014/main" xmlns="" val="3112482941"/>
                    </a:ext>
                  </a:extLst>
                </a:gridCol>
                <a:gridCol w="1307032">
                  <a:extLst>
                    <a:ext uri="{9D8B030D-6E8A-4147-A177-3AD203B41FA5}">
                      <a16:colId xmlns:a16="http://schemas.microsoft.com/office/drawing/2014/main" xmlns="" val="2083353072"/>
                    </a:ext>
                  </a:extLst>
                </a:gridCol>
              </a:tblGrid>
              <a:tr h="30485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</a:t>
                      </a:r>
                      <a:r>
                        <a:rPr lang="en-US" altLang="ko-KR" sz="1000" b="1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µM)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. tuberculosis H37Rv </a:t>
                      </a: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26723231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ionylpromazine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914022375"/>
                  </a:ext>
                </a:extLst>
              </a:tr>
              <a:tr h="3048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Q</a:t>
                      </a:r>
                      <a:endParaRPr lang="ko-KR" alt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96835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9497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3</TotalTime>
  <Words>83</Words>
  <Application>Microsoft Office PowerPoint</Application>
  <PresentationFormat>Widescreen</PresentationFormat>
  <Paragraphs>2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맑은 고딕</vt:lpstr>
      <vt:lpstr>Arial</vt:lpstr>
      <vt:lpstr>Calibri</vt:lpstr>
      <vt:lpstr>Times New Roman</vt:lpstr>
      <vt:lpstr>Office 테마</vt:lpstr>
      <vt:lpstr>1_Office 테마</vt:lpstr>
      <vt:lpstr>GraphPad Prism 9 Projec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MA-Microscopy</dc:creator>
  <cp:lastModifiedBy>MMA</cp:lastModifiedBy>
  <cp:revision>109</cp:revision>
  <dcterms:created xsi:type="dcterms:W3CDTF">2022-02-08T05:45:52Z</dcterms:created>
  <dcterms:modified xsi:type="dcterms:W3CDTF">2024-04-16T08:27:51Z</dcterms:modified>
</cp:coreProperties>
</file>